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65686-2E9B-4142-BC79-73B181CAEF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1CC29-2CA4-4F18-8F90-904E0872E9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BAC36-838B-4D15-9C2D-0A9572C0F9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215F6-2D65-43AE-AA60-C672017B09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C6B95-3742-4409-9028-1FBD536867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C17E5-5AFC-4EE3-8FAA-16ED288197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25813-4F10-4531-BB33-BA17A91339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2C5B1-AE1B-4328-8152-2D01470BF0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45D60-FB2E-4B11-82F8-AE68A99B6A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02B68-E2F1-45B4-93A2-36C3C10588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1A767-DBBD-49B6-B7D6-44D990E4AC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00352B-AFA0-444A-B53D-CEB0E86622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0BCA5B-C22E-4FFA-8972-FB63ADE476B5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63640" y="404640"/>
            <a:ext cx="56167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000000"/>
                </a:solidFill>
                <a:latin typeface="Arial"/>
              </a:rPr>
              <a:t>P-P Plot of the variable Log (</a:t>
            </a:r>
            <a:r>
              <a:rPr b="0" i="1" lang="it-IT" sz="24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i="1" lang="it-IT" sz="2400" spc="-1" strike="noStrike" baseline="-25000">
                <a:solidFill>
                  <a:srgbClr val="000000"/>
                </a:solidFill>
                <a:latin typeface="Arial"/>
              </a:rPr>
              <a:t>ob</a:t>
            </a:r>
            <a:r>
              <a:rPr b="0" i="1" lang="it-IT" sz="2400" spc="-1" strike="noStrike">
                <a:solidFill>
                  <a:srgbClr val="000000"/>
                </a:solidFill>
                <a:latin typeface="Arial"/>
              </a:rPr>
              <a:t>/N</a:t>
            </a:r>
            <a:r>
              <a:rPr b="0" i="1" lang="it-IT" sz="2400" spc="-1" strike="noStrike" baseline="-25000">
                <a:solidFill>
                  <a:srgbClr val="000000"/>
                </a:solidFill>
                <a:latin typeface="Arial"/>
              </a:rPr>
              <a:t>exp</a:t>
            </a:r>
            <a:r>
              <a:rPr b="0" lang="it-IT" sz="2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84080" y="1442880"/>
            <a:ext cx="4104000" cy="380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803160" y="514512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803160" y="5100480"/>
            <a:ext cx="3672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30160" y="5043600"/>
            <a:ext cx="3816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39880" y="498780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33480" y="494352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941400" y="488808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015920" y="483228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100160" y="477684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65320" y="473220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230480" y="467676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285920" y="462132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406520" y="4575240"/>
            <a:ext cx="3636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452600" y="451944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19280" y="446400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778040" y="440856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78040" y="436392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778040" y="430848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852560" y="425304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870200" y="4208400"/>
            <a:ext cx="3780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908000" y="415296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009880" y="4095720"/>
            <a:ext cx="3636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019240" y="404028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120760" y="399564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205000" y="394020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371680" y="388476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511360" y="3840120"/>
            <a:ext cx="3672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11360" y="378468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612880" y="372888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658960" y="367344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779560" y="3627360"/>
            <a:ext cx="3816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882880" y="357192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92600" y="351648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938320" y="3471840"/>
            <a:ext cx="3672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948040" y="341640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021120" y="336060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030480" y="331632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030480" y="326088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133800" y="320508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151080" y="3147840"/>
            <a:ext cx="3816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170160" y="310356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198960" y="304812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198960" y="299232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290760" y="294804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421080" y="289260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486240" y="283680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532320" y="278136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560760" y="273672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560760" y="2679840"/>
            <a:ext cx="36360" cy="4572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4040" bIns="-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597120" y="2624040"/>
            <a:ext cx="3672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606840" y="257976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616200" y="2523960"/>
            <a:ext cx="3672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746520" y="246852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763800" y="241308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875040" y="236844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884760" y="2313000"/>
            <a:ext cx="3780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884760" y="2257560"/>
            <a:ext cx="3780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894120" y="2211480"/>
            <a:ext cx="3816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903840" y="215568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913200" y="210024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932280" y="205596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997440" y="200016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164120" y="1944720"/>
            <a:ext cx="363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181400" y="188928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219560" y="184464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246560" y="178920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460760" y="1731960"/>
            <a:ext cx="3672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506840" y="168768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4552920" y="1631880"/>
            <a:ext cx="381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562640" y="1576440"/>
            <a:ext cx="3780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572000" y="1521000"/>
            <a:ext cx="3816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757760" y="1476360"/>
            <a:ext cx="36360" cy="4464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786200" y="1420920"/>
            <a:ext cx="3672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784080" y="1442880"/>
            <a:ext cx="4084920" cy="3780000"/>
          </a:xfrm>
          <a:custGeom>
            <a:avLst/>
            <a:gdLst/>
            <a:ahLst/>
            <a:rect l="l" t="t" r="r" b="b"/>
            <a:pathLst>
              <a:path w="2573" h="2381">
                <a:moveTo>
                  <a:pt x="0" y="2381"/>
                </a:moveTo>
                <a:lnTo>
                  <a:pt x="12" y="2367"/>
                </a:lnTo>
                <a:lnTo>
                  <a:pt x="23" y="2360"/>
                </a:lnTo>
                <a:lnTo>
                  <a:pt x="41" y="2346"/>
                </a:lnTo>
                <a:lnTo>
                  <a:pt x="53" y="2332"/>
                </a:lnTo>
                <a:lnTo>
                  <a:pt x="64" y="2325"/>
                </a:lnTo>
                <a:lnTo>
                  <a:pt x="76" y="2311"/>
                </a:lnTo>
                <a:lnTo>
                  <a:pt x="88" y="2297"/>
                </a:lnTo>
                <a:lnTo>
                  <a:pt x="105" y="2283"/>
                </a:lnTo>
                <a:lnTo>
                  <a:pt x="117" y="2275"/>
                </a:lnTo>
                <a:lnTo>
                  <a:pt x="129" y="2261"/>
                </a:lnTo>
                <a:lnTo>
                  <a:pt x="140" y="2247"/>
                </a:lnTo>
                <a:lnTo>
                  <a:pt x="158" y="2240"/>
                </a:lnTo>
                <a:lnTo>
                  <a:pt x="170" y="2226"/>
                </a:lnTo>
                <a:lnTo>
                  <a:pt x="181" y="2212"/>
                </a:lnTo>
                <a:lnTo>
                  <a:pt x="193" y="2205"/>
                </a:lnTo>
                <a:lnTo>
                  <a:pt x="205" y="2191"/>
                </a:lnTo>
                <a:lnTo>
                  <a:pt x="222" y="2177"/>
                </a:lnTo>
                <a:lnTo>
                  <a:pt x="234" y="2163"/>
                </a:lnTo>
                <a:lnTo>
                  <a:pt x="246" y="2156"/>
                </a:lnTo>
                <a:lnTo>
                  <a:pt x="257" y="2142"/>
                </a:lnTo>
                <a:lnTo>
                  <a:pt x="269" y="2128"/>
                </a:lnTo>
                <a:lnTo>
                  <a:pt x="287" y="2121"/>
                </a:lnTo>
                <a:lnTo>
                  <a:pt x="298" y="2107"/>
                </a:lnTo>
                <a:lnTo>
                  <a:pt x="310" y="2093"/>
                </a:lnTo>
                <a:lnTo>
                  <a:pt x="322" y="2079"/>
                </a:lnTo>
                <a:lnTo>
                  <a:pt x="333" y="2072"/>
                </a:lnTo>
                <a:lnTo>
                  <a:pt x="351" y="2058"/>
                </a:lnTo>
                <a:lnTo>
                  <a:pt x="363" y="2044"/>
                </a:lnTo>
                <a:lnTo>
                  <a:pt x="374" y="2037"/>
                </a:lnTo>
                <a:lnTo>
                  <a:pt x="386" y="2023"/>
                </a:lnTo>
                <a:lnTo>
                  <a:pt x="398" y="2009"/>
                </a:lnTo>
                <a:lnTo>
                  <a:pt x="415" y="2002"/>
                </a:lnTo>
                <a:lnTo>
                  <a:pt x="427" y="1988"/>
                </a:lnTo>
                <a:lnTo>
                  <a:pt x="439" y="1973"/>
                </a:lnTo>
                <a:lnTo>
                  <a:pt x="450" y="1959"/>
                </a:lnTo>
                <a:lnTo>
                  <a:pt x="468" y="1952"/>
                </a:lnTo>
                <a:lnTo>
                  <a:pt x="480" y="1938"/>
                </a:lnTo>
                <a:lnTo>
                  <a:pt x="491" y="1924"/>
                </a:lnTo>
                <a:lnTo>
                  <a:pt x="503" y="1917"/>
                </a:lnTo>
                <a:lnTo>
                  <a:pt x="515" y="1903"/>
                </a:lnTo>
                <a:lnTo>
                  <a:pt x="532" y="1889"/>
                </a:lnTo>
                <a:lnTo>
                  <a:pt x="544" y="1882"/>
                </a:lnTo>
                <a:lnTo>
                  <a:pt x="556" y="1868"/>
                </a:lnTo>
                <a:lnTo>
                  <a:pt x="567" y="1854"/>
                </a:lnTo>
                <a:lnTo>
                  <a:pt x="579" y="1840"/>
                </a:lnTo>
                <a:lnTo>
                  <a:pt x="597" y="1833"/>
                </a:lnTo>
                <a:lnTo>
                  <a:pt x="608" y="1819"/>
                </a:lnTo>
                <a:lnTo>
                  <a:pt x="620" y="1805"/>
                </a:lnTo>
                <a:lnTo>
                  <a:pt x="632" y="1798"/>
                </a:lnTo>
                <a:lnTo>
                  <a:pt x="643" y="1784"/>
                </a:lnTo>
                <a:lnTo>
                  <a:pt x="661" y="1770"/>
                </a:lnTo>
                <a:lnTo>
                  <a:pt x="673" y="1756"/>
                </a:lnTo>
                <a:lnTo>
                  <a:pt x="684" y="1749"/>
                </a:lnTo>
                <a:lnTo>
                  <a:pt x="696" y="1735"/>
                </a:lnTo>
                <a:lnTo>
                  <a:pt x="713" y="1721"/>
                </a:lnTo>
                <a:lnTo>
                  <a:pt x="725" y="1714"/>
                </a:lnTo>
                <a:lnTo>
                  <a:pt x="737" y="1700"/>
                </a:lnTo>
                <a:lnTo>
                  <a:pt x="749" y="1686"/>
                </a:lnTo>
                <a:lnTo>
                  <a:pt x="760" y="1678"/>
                </a:lnTo>
                <a:lnTo>
                  <a:pt x="778" y="1664"/>
                </a:lnTo>
                <a:lnTo>
                  <a:pt x="790" y="1650"/>
                </a:lnTo>
                <a:lnTo>
                  <a:pt x="801" y="1636"/>
                </a:lnTo>
                <a:lnTo>
                  <a:pt x="813" y="1629"/>
                </a:lnTo>
                <a:lnTo>
                  <a:pt x="825" y="1615"/>
                </a:lnTo>
                <a:lnTo>
                  <a:pt x="842" y="1601"/>
                </a:lnTo>
                <a:lnTo>
                  <a:pt x="854" y="1594"/>
                </a:lnTo>
                <a:lnTo>
                  <a:pt x="866" y="1580"/>
                </a:lnTo>
                <a:lnTo>
                  <a:pt x="877" y="1566"/>
                </a:lnTo>
                <a:lnTo>
                  <a:pt x="895" y="1559"/>
                </a:lnTo>
                <a:lnTo>
                  <a:pt x="906" y="1545"/>
                </a:lnTo>
                <a:lnTo>
                  <a:pt x="918" y="1531"/>
                </a:lnTo>
                <a:lnTo>
                  <a:pt x="930" y="1517"/>
                </a:lnTo>
                <a:lnTo>
                  <a:pt x="942" y="1510"/>
                </a:lnTo>
                <a:lnTo>
                  <a:pt x="959" y="1496"/>
                </a:lnTo>
                <a:lnTo>
                  <a:pt x="971" y="1482"/>
                </a:lnTo>
                <a:lnTo>
                  <a:pt x="983" y="1475"/>
                </a:lnTo>
                <a:lnTo>
                  <a:pt x="994" y="1461"/>
                </a:lnTo>
                <a:lnTo>
                  <a:pt x="1006" y="1447"/>
                </a:lnTo>
                <a:lnTo>
                  <a:pt x="1023" y="1433"/>
                </a:lnTo>
                <a:lnTo>
                  <a:pt x="1035" y="1426"/>
                </a:lnTo>
                <a:lnTo>
                  <a:pt x="1047" y="1412"/>
                </a:lnTo>
                <a:lnTo>
                  <a:pt x="1059" y="1398"/>
                </a:lnTo>
                <a:lnTo>
                  <a:pt x="1070" y="1391"/>
                </a:lnTo>
                <a:lnTo>
                  <a:pt x="1088" y="1376"/>
                </a:lnTo>
                <a:lnTo>
                  <a:pt x="1099" y="1362"/>
                </a:lnTo>
                <a:lnTo>
                  <a:pt x="1111" y="1355"/>
                </a:lnTo>
                <a:lnTo>
                  <a:pt x="1123" y="1341"/>
                </a:lnTo>
                <a:lnTo>
                  <a:pt x="1140" y="1327"/>
                </a:lnTo>
                <a:lnTo>
                  <a:pt x="1152" y="1313"/>
                </a:lnTo>
                <a:lnTo>
                  <a:pt x="1164" y="1306"/>
                </a:lnTo>
                <a:lnTo>
                  <a:pt x="1176" y="1292"/>
                </a:lnTo>
                <a:lnTo>
                  <a:pt x="1187" y="1278"/>
                </a:lnTo>
                <a:lnTo>
                  <a:pt x="1205" y="1271"/>
                </a:lnTo>
                <a:lnTo>
                  <a:pt x="1216" y="1257"/>
                </a:lnTo>
                <a:lnTo>
                  <a:pt x="1228" y="1243"/>
                </a:lnTo>
                <a:lnTo>
                  <a:pt x="1240" y="1236"/>
                </a:lnTo>
                <a:lnTo>
                  <a:pt x="1252" y="1222"/>
                </a:lnTo>
                <a:lnTo>
                  <a:pt x="1269" y="1208"/>
                </a:lnTo>
                <a:lnTo>
                  <a:pt x="1281" y="1194"/>
                </a:lnTo>
                <a:lnTo>
                  <a:pt x="1292" y="1187"/>
                </a:lnTo>
                <a:lnTo>
                  <a:pt x="1304" y="1173"/>
                </a:lnTo>
                <a:lnTo>
                  <a:pt x="1316" y="1159"/>
                </a:lnTo>
                <a:lnTo>
                  <a:pt x="1333" y="1152"/>
                </a:lnTo>
                <a:lnTo>
                  <a:pt x="1345" y="1138"/>
                </a:lnTo>
                <a:lnTo>
                  <a:pt x="1357" y="1124"/>
                </a:lnTo>
                <a:lnTo>
                  <a:pt x="1368" y="1110"/>
                </a:lnTo>
                <a:lnTo>
                  <a:pt x="1386" y="1103"/>
                </a:lnTo>
                <a:lnTo>
                  <a:pt x="1398" y="1088"/>
                </a:lnTo>
                <a:lnTo>
                  <a:pt x="1409" y="1074"/>
                </a:lnTo>
                <a:lnTo>
                  <a:pt x="1421" y="1067"/>
                </a:lnTo>
                <a:lnTo>
                  <a:pt x="1433" y="1053"/>
                </a:lnTo>
                <a:lnTo>
                  <a:pt x="1450" y="1039"/>
                </a:lnTo>
                <a:lnTo>
                  <a:pt x="1462" y="1032"/>
                </a:lnTo>
                <a:lnTo>
                  <a:pt x="1474" y="1018"/>
                </a:lnTo>
                <a:lnTo>
                  <a:pt x="1485" y="1004"/>
                </a:lnTo>
                <a:lnTo>
                  <a:pt x="1497" y="990"/>
                </a:lnTo>
                <a:lnTo>
                  <a:pt x="1515" y="983"/>
                </a:lnTo>
                <a:lnTo>
                  <a:pt x="1526" y="969"/>
                </a:lnTo>
                <a:lnTo>
                  <a:pt x="1538" y="955"/>
                </a:lnTo>
                <a:lnTo>
                  <a:pt x="1550" y="948"/>
                </a:lnTo>
                <a:lnTo>
                  <a:pt x="1561" y="934"/>
                </a:lnTo>
                <a:lnTo>
                  <a:pt x="1579" y="920"/>
                </a:lnTo>
                <a:lnTo>
                  <a:pt x="1591" y="913"/>
                </a:lnTo>
                <a:lnTo>
                  <a:pt x="1602" y="899"/>
                </a:lnTo>
                <a:lnTo>
                  <a:pt x="1614" y="885"/>
                </a:lnTo>
                <a:lnTo>
                  <a:pt x="1632" y="871"/>
                </a:lnTo>
                <a:lnTo>
                  <a:pt x="1643" y="864"/>
                </a:lnTo>
                <a:lnTo>
                  <a:pt x="1655" y="850"/>
                </a:lnTo>
                <a:lnTo>
                  <a:pt x="1667" y="836"/>
                </a:lnTo>
                <a:lnTo>
                  <a:pt x="1678" y="829"/>
                </a:lnTo>
                <a:lnTo>
                  <a:pt x="1696" y="815"/>
                </a:lnTo>
                <a:lnTo>
                  <a:pt x="1708" y="801"/>
                </a:lnTo>
                <a:lnTo>
                  <a:pt x="1719" y="786"/>
                </a:lnTo>
                <a:lnTo>
                  <a:pt x="1731" y="779"/>
                </a:lnTo>
                <a:lnTo>
                  <a:pt x="1743" y="765"/>
                </a:lnTo>
                <a:lnTo>
                  <a:pt x="1760" y="751"/>
                </a:lnTo>
                <a:lnTo>
                  <a:pt x="1772" y="744"/>
                </a:lnTo>
                <a:lnTo>
                  <a:pt x="1784" y="730"/>
                </a:lnTo>
                <a:lnTo>
                  <a:pt x="1795" y="716"/>
                </a:lnTo>
                <a:lnTo>
                  <a:pt x="1813" y="709"/>
                </a:lnTo>
                <a:lnTo>
                  <a:pt x="1825" y="695"/>
                </a:lnTo>
                <a:lnTo>
                  <a:pt x="1836" y="681"/>
                </a:lnTo>
                <a:lnTo>
                  <a:pt x="1848" y="667"/>
                </a:lnTo>
                <a:lnTo>
                  <a:pt x="1860" y="660"/>
                </a:lnTo>
                <a:lnTo>
                  <a:pt x="1877" y="646"/>
                </a:lnTo>
                <a:lnTo>
                  <a:pt x="1889" y="632"/>
                </a:lnTo>
                <a:lnTo>
                  <a:pt x="1901" y="625"/>
                </a:lnTo>
                <a:lnTo>
                  <a:pt x="1912" y="611"/>
                </a:lnTo>
                <a:lnTo>
                  <a:pt x="1924" y="597"/>
                </a:lnTo>
                <a:lnTo>
                  <a:pt x="1942" y="583"/>
                </a:lnTo>
                <a:lnTo>
                  <a:pt x="1953" y="576"/>
                </a:lnTo>
                <a:lnTo>
                  <a:pt x="1965" y="562"/>
                </a:lnTo>
                <a:lnTo>
                  <a:pt x="1977" y="548"/>
                </a:lnTo>
                <a:lnTo>
                  <a:pt x="1988" y="541"/>
                </a:lnTo>
                <a:lnTo>
                  <a:pt x="2006" y="527"/>
                </a:lnTo>
                <a:lnTo>
                  <a:pt x="2018" y="513"/>
                </a:lnTo>
                <a:lnTo>
                  <a:pt x="2029" y="506"/>
                </a:lnTo>
                <a:lnTo>
                  <a:pt x="2041" y="491"/>
                </a:lnTo>
                <a:lnTo>
                  <a:pt x="2053" y="477"/>
                </a:lnTo>
                <a:lnTo>
                  <a:pt x="2070" y="463"/>
                </a:lnTo>
                <a:lnTo>
                  <a:pt x="2082" y="456"/>
                </a:lnTo>
                <a:lnTo>
                  <a:pt x="2094" y="442"/>
                </a:lnTo>
                <a:lnTo>
                  <a:pt x="2105" y="428"/>
                </a:lnTo>
                <a:lnTo>
                  <a:pt x="2123" y="421"/>
                </a:lnTo>
                <a:lnTo>
                  <a:pt x="2135" y="407"/>
                </a:lnTo>
                <a:lnTo>
                  <a:pt x="2146" y="393"/>
                </a:lnTo>
                <a:lnTo>
                  <a:pt x="2158" y="386"/>
                </a:lnTo>
                <a:lnTo>
                  <a:pt x="2170" y="372"/>
                </a:lnTo>
                <a:lnTo>
                  <a:pt x="2187" y="358"/>
                </a:lnTo>
                <a:lnTo>
                  <a:pt x="2199" y="344"/>
                </a:lnTo>
                <a:lnTo>
                  <a:pt x="2211" y="337"/>
                </a:lnTo>
                <a:lnTo>
                  <a:pt x="2222" y="323"/>
                </a:lnTo>
                <a:lnTo>
                  <a:pt x="2234" y="309"/>
                </a:lnTo>
                <a:lnTo>
                  <a:pt x="2252" y="302"/>
                </a:lnTo>
                <a:lnTo>
                  <a:pt x="2263" y="288"/>
                </a:lnTo>
                <a:lnTo>
                  <a:pt x="2275" y="274"/>
                </a:lnTo>
                <a:lnTo>
                  <a:pt x="2287" y="260"/>
                </a:lnTo>
                <a:lnTo>
                  <a:pt x="2298" y="253"/>
                </a:lnTo>
                <a:lnTo>
                  <a:pt x="2316" y="239"/>
                </a:lnTo>
                <a:lnTo>
                  <a:pt x="2328" y="225"/>
                </a:lnTo>
                <a:lnTo>
                  <a:pt x="2339" y="218"/>
                </a:lnTo>
                <a:lnTo>
                  <a:pt x="2351" y="204"/>
                </a:lnTo>
                <a:lnTo>
                  <a:pt x="2369" y="189"/>
                </a:lnTo>
                <a:lnTo>
                  <a:pt x="2380" y="182"/>
                </a:lnTo>
                <a:lnTo>
                  <a:pt x="2392" y="168"/>
                </a:lnTo>
                <a:lnTo>
                  <a:pt x="2404" y="154"/>
                </a:lnTo>
                <a:lnTo>
                  <a:pt x="2415" y="140"/>
                </a:lnTo>
                <a:lnTo>
                  <a:pt x="2433" y="133"/>
                </a:lnTo>
                <a:lnTo>
                  <a:pt x="2445" y="119"/>
                </a:lnTo>
                <a:lnTo>
                  <a:pt x="2456" y="105"/>
                </a:lnTo>
                <a:lnTo>
                  <a:pt x="2468" y="98"/>
                </a:lnTo>
                <a:lnTo>
                  <a:pt x="2480" y="84"/>
                </a:lnTo>
                <a:lnTo>
                  <a:pt x="2497" y="70"/>
                </a:lnTo>
                <a:lnTo>
                  <a:pt x="2509" y="63"/>
                </a:lnTo>
                <a:lnTo>
                  <a:pt x="2521" y="49"/>
                </a:lnTo>
                <a:lnTo>
                  <a:pt x="2532" y="35"/>
                </a:lnTo>
                <a:lnTo>
                  <a:pt x="2550" y="21"/>
                </a:lnTo>
                <a:lnTo>
                  <a:pt x="2562" y="14"/>
                </a:lnTo>
                <a:lnTo>
                  <a:pt x="2573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784080" y="5222880"/>
            <a:ext cx="4084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784080" y="5200560"/>
            <a:ext cx="180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601640" y="5200560"/>
            <a:ext cx="180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417760" y="520056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235320" y="520056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052880" y="520056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869000" y="520056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708480" y="52894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526040" y="52894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334240" y="52894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150000" y="52894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967560" y="52894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793040" y="52894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,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608480" y="5535720"/>
            <a:ext cx="2963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Theoretical cumulative distribu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784080" y="1442880"/>
            <a:ext cx="4084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784080" y="1442880"/>
            <a:ext cx="180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V="1">
            <a:off x="1601640" y="1442880"/>
            <a:ext cx="180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2417760" y="144288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flipV="1">
            <a:off x="3235320" y="144288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4052880" y="144288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4869000" y="144288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V="1">
            <a:off x="784080" y="1442880"/>
            <a:ext cx="1800" cy="3780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H="1">
            <a:off x="784080" y="522288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H="1">
            <a:off x="784080" y="4464000"/>
            <a:ext cx="28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H="1">
            <a:off x="784080" y="370692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H="1">
            <a:off x="784080" y="295920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H="1">
            <a:off x="784080" y="220032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H="1">
            <a:off x="784080" y="1442880"/>
            <a:ext cx="28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560880" y="514512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560880" y="438624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60880" y="362736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60880" y="28702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560880" y="211140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,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560880" y="136512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,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rot="16200000">
            <a:off x="-985320" y="2931480"/>
            <a:ext cx="2817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Empirical cumulative distribu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4869000" y="1442880"/>
            <a:ext cx="1440" cy="3780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842000" y="5222880"/>
            <a:ext cx="27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842000" y="4464000"/>
            <a:ext cx="27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842000" y="3706920"/>
            <a:ext cx="27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842000" y="2959200"/>
            <a:ext cx="27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842000" y="2200320"/>
            <a:ext cx="27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842000" y="1442880"/>
            <a:ext cx="27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973760" y="1341360"/>
            <a:ext cx="3827520" cy="2508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973760" y="1341360"/>
            <a:ext cx="1440" cy="1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5070600" y="1438200"/>
            <a:ext cx="3652560" cy="27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5927400" y="1457280"/>
            <a:ext cx="2365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One-Sample Kolmogorov-Smirnov Te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7942320" y="1871640"/>
            <a:ext cx="780840" cy="203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8453160" y="18907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7942320" y="2055960"/>
            <a:ext cx="78084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8308080" y="207504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0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7942320" y="2238480"/>
            <a:ext cx="780840" cy="203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8249040" y="2257560"/>
            <a:ext cx="38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041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7942320" y="2422440"/>
            <a:ext cx="78084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8365320" y="2441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1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7942320" y="2604960"/>
            <a:ext cx="780840" cy="203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8365320" y="2624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05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7942320" y="2789280"/>
            <a:ext cx="78084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8336880" y="280836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,1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7942320" y="2971800"/>
            <a:ext cx="780840" cy="203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8365320" y="2990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8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7942320" y="3156120"/>
            <a:ext cx="78084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8365320" y="3174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4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5070600" y="1689120"/>
            <a:ext cx="289080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070600" y="1871640"/>
            <a:ext cx="2890800" cy="203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5146560" y="1881360"/>
            <a:ext cx="92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6507000" y="2055960"/>
            <a:ext cx="145440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6583320" y="2065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e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507000" y="2238480"/>
            <a:ext cx="1454400" cy="203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6583320" y="2247840"/>
            <a:ext cx="785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td. Devi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5070600" y="2055960"/>
            <a:ext cx="1455480" cy="385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5147640" y="2065320"/>
            <a:ext cx="1096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Normal Paramet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6507000" y="2422440"/>
            <a:ext cx="145440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6582960" y="2432160"/>
            <a:ext cx="491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Absolu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6507000" y="2604960"/>
            <a:ext cx="1454400" cy="203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6583320" y="261468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6507000" y="2789280"/>
            <a:ext cx="145440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6583320" y="2798640"/>
            <a:ext cx="498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g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5070600" y="2422440"/>
            <a:ext cx="1455480" cy="568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5146560" y="243216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st Extre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5146200" y="2585880"/>
            <a:ext cx="640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Differenc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5070600" y="2971800"/>
            <a:ext cx="2890800" cy="203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5147640" y="2981160"/>
            <a:ext cx="1293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Kolmogorov-Smirnov 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5070600" y="3156120"/>
            <a:ext cx="289080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147640" y="3165480"/>
            <a:ext cx="120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Asymp. Sig. (2-taile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7942320" y="1689120"/>
            <a:ext cx="78084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7782840" y="1717560"/>
            <a:ext cx="893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Log (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</a:rPr>
              <a:t>Nob/Nexp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5060880" y="3338640"/>
            <a:ext cx="3662280" cy="231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5060880" y="3551400"/>
            <a:ext cx="3662280" cy="231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5205240" y="3551400"/>
            <a:ext cx="3517920" cy="231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5060880" y="3762360"/>
            <a:ext cx="36435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973760" y="1341360"/>
            <a:ext cx="3827520" cy="96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973760" y="1341360"/>
            <a:ext cx="96840" cy="2517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8704440" y="1341360"/>
            <a:ext cx="106200" cy="2517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4973760" y="3762360"/>
            <a:ext cx="3827520" cy="106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5070600" y="1689120"/>
            <a:ext cx="1440" cy="1649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8713800" y="1689120"/>
            <a:ext cx="1440" cy="1658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5070600" y="1689120"/>
            <a:ext cx="36338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5070600" y="3348000"/>
            <a:ext cx="36432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5079960" y="1881360"/>
            <a:ext cx="36147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7740720" y="1698480"/>
            <a:ext cx="1440" cy="1630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30T14:50:12Z</dcterms:created>
  <dc:creator>Michele Guescini</dc:creator>
  <dc:description/>
  <dc:language>en-US</dc:language>
  <cp:lastModifiedBy>Michele Guescini</cp:lastModifiedBy>
  <dcterms:modified xsi:type="dcterms:W3CDTF">2010-02-18T17:52:01Z</dcterms:modified>
  <cp:revision>3</cp:revision>
  <dc:subject/>
  <dc:title>Diapositiva 1</dc:title>
</cp:coreProperties>
</file>